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629033-1466-4AA5-BDFD-EA8DA2D9972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128D3C-A0DF-49F9-BC95-9B56F340FD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E39DA8-0D6F-47D6-BEDA-D9CE3FA3D6B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A261CB-729A-4C9F-9E2F-81BF731C0A4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001699-CC79-4018-B8AD-CF0FCB7414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326EBE-0BB7-44BA-87E9-F75E7B88C4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A5FFC6-8945-44AE-99BE-05947FCE47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AA7F2D-8554-4DF3-8671-DA9735824E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835D36-5106-4F6E-BEBE-ADDE583E13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EE6F15-BED5-4633-A839-00FB60013D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DBB2B8-6385-4DBC-8DBF-A3D1DD0731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1A69E7-69F0-4A63-9B53-09F5E02320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3E716FC-B55A-4696-8B50-15929ADB61C9}" type="slidenum">
              <a:rPr b="0" lang="es-MX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3 Rectángulo"/>
          <p:cNvSpPr/>
          <p:nvPr/>
        </p:nvSpPr>
        <p:spPr>
          <a:xfrm>
            <a:off x="351000" y="0"/>
            <a:ext cx="80658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. Combined prevalence of overweight and obesity in female adolescents by area of residency (A) and household living conditions index (HLCI) (B) and year of survey: 1988-2012</a:t>
            </a:r>
            <a:r>
              <a:rPr b="0" lang="en-US" sz="14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-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4 Rectángulo"/>
          <p:cNvSpPr/>
          <p:nvPr/>
        </p:nvSpPr>
        <p:spPr>
          <a:xfrm>
            <a:off x="465840" y="461880"/>
            <a:ext cx="1657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. Area of residenc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6 Rectángulo"/>
          <p:cNvSpPr/>
          <p:nvPr/>
        </p:nvSpPr>
        <p:spPr>
          <a:xfrm>
            <a:off x="406800" y="3273480"/>
            <a:ext cx="802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. HLCI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1 Rectángulo"/>
          <p:cNvSpPr/>
          <p:nvPr/>
        </p:nvSpPr>
        <p:spPr>
          <a:xfrm>
            <a:off x="558720" y="6211800"/>
            <a:ext cx="78580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 Percentage and 95% C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 Age groups defined as: Adolescents: 12-19 year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3 Area of residency: Change in prevalence from 2006-2012: Urban: 2.6 ±0.1 pp, p=0.01; rural: 1.4 ± 1.3 pp, p=0.2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4 Household living condition index (HLCI): Change in prevalence from 2006-2012: Lowest HLCI quintile: 4.7±1.6 pp, p=0.003; Highest HLCI quintile: 2.6±2.0 pp, p=0.1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5" name="4 Gráfico" descr=""/>
          <p:cNvPicPr/>
          <p:nvPr/>
        </p:nvPicPr>
        <p:blipFill>
          <a:blip r:embed="rId1"/>
          <a:stretch/>
        </p:blipFill>
        <p:spPr>
          <a:xfrm>
            <a:off x="493560" y="663480"/>
            <a:ext cx="5086440" cy="2617920"/>
          </a:xfrm>
          <a:prstGeom prst="rect">
            <a:avLst/>
          </a:prstGeom>
          <a:ln w="0">
            <a:noFill/>
          </a:ln>
        </p:spPr>
      </p:pic>
      <p:pic>
        <p:nvPicPr>
          <p:cNvPr id="46" name="2 Gráfico" descr=""/>
          <p:cNvPicPr/>
          <p:nvPr/>
        </p:nvPicPr>
        <p:blipFill>
          <a:blip r:embed="rId2"/>
          <a:stretch/>
        </p:blipFill>
        <p:spPr>
          <a:xfrm>
            <a:off x="511200" y="3581280"/>
            <a:ext cx="7589880" cy="2667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5-26T16:01:36Z</dcterms:created>
  <dc:creator>Sonia Lizeth Hernández Cordero</dc:creator>
  <dc:description/>
  <dc:language>en-US</dc:language>
  <cp:lastModifiedBy>Satish.d</cp:lastModifiedBy>
  <dcterms:modified xsi:type="dcterms:W3CDTF">2017-02-20T04:09:20Z</dcterms:modified>
  <cp:revision>11</cp:revision>
  <dc:subject/>
  <dc:title>Presentación de PowerPoint</dc:title>
</cp:coreProperties>
</file>